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5833"/>
  </p:normalViewPr>
  <p:slideViewPr>
    <p:cSldViewPr snapToGrid="0">
      <p:cViewPr varScale="1">
        <p:scale>
          <a:sx n="97" d="100"/>
          <a:sy n="97" d="100"/>
        </p:scale>
        <p:origin x="78" y="8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sarahtebeka\Dropbox\SPF\COVID%20long\JAMA%20Psy\Fig%20S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 sz="1800" b="1" i="0" baseline="0">
                <a:effectLst/>
              </a:rPr>
              <a:t>Figure S2</a:t>
            </a:r>
            <a:r>
              <a:rPr lang="fr-FR" sz="1800" b="0" i="0" baseline="0">
                <a:effectLst/>
              </a:rPr>
              <a:t>. Impact of the length of time since SARS-COV-2 infection on the intensity of mesured anxiety and depression (GAD-2 and PHQ-2 scores) among post-COVID-19 condition participants </a:t>
            </a:r>
            <a:endParaRPr lang="fr-FR" sz="2000">
              <a:effectLst/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>
        <c:manualLayout>
          <c:layoutTarget val="inner"/>
          <c:xMode val="edge"/>
          <c:yMode val="edge"/>
          <c:x val="4.0292826644532681E-2"/>
          <c:y val="0.23122651619660933"/>
          <c:w val="0.92931780963277022"/>
          <c:h val="0.63771655244358816"/>
        </c:manualLayout>
      </c:layout>
      <c:lineChart>
        <c:grouping val="standard"/>
        <c:varyColors val="0"/>
        <c:ser>
          <c:idx val="1"/>
          <c:order val="0"/>
          <c:tx>
            <c:strRef>
              <c:f>'[1]Fig S1 Ancienneté du COVID'!$A$13</c:f>
              <c:strCache>
                <c:ptCount val="1"/>
                <c:pt idx="0">
                  <c:v>anxiety score (GAD-2)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'[1]Fig S1 Ancienneté du COVID'!$B$11:$E$11</c:f>
              <c:strCache>
                <c:ptCount val="4"/>
                <c:pt idx="0">
                  <c:v>3-6 months (N=413)</c:v>
                </c:pt>
                <c:pt idx="1">
                  <c:v>6-12 months (N=213)</c:v>
                </c:pt>
                <c:pt idx="2">
                  <c:v>12-18 months (N=299)</c:v>
                </c:pt>
                <c:pt idx="3">
                  <c:v>&gt;18 months (N=161)</c:v>
                </c:pt>
              </c:strCache>
            </c:strRef>
          </c:cat>
          <c:val>
            <c:numRef>
              <c:f>'[1]Fig S1 Ancienneté du COVID'!$B$13:$E$13</c:f>
              <c:numCache>
                <c:formatCode>General</c:formatCode>
                <c:ptCount val="4"/>
                <c:pt idx="0">
                  <c:v>3.608047</c:v>
                </c:pt>
                <c:pt idx="1">
                  <c:v>3.8187199999999999</c:v>
                </c:pt>
                <c:pt idx="2">
                  <c:v>3.5672999999999999</c:v>
                </c:pt>
                <c:pt idx="3">
                  <c:v>3.6636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034-5C40-8AC0-426C05C3D8F6}"/>
            </c:ext>
          </c:extLst>
        </c:ser>
        <c:ser>
          <c:idx val="2"/>
          <c:order val="1"/>
          <c:tx>
            <c:strRef>
              <c:f>'[1]Fig S1 Ancienneté du COVID'!$A$14</c:f>
              <c:strCache>
                <c:ptCount val="1"/>
                <c:pt idx="0">
                  <c:v>depression score (PHQ-2)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'[1]Fig S1 Ancienneté du COVID'!$B$11:$E$11</c:f>
              <c:strCache>
                <c:ptCount val="4"/>
                <c:pt idx="0">
                  <c:v>3-6 months (N=413)</c:v>
                </c:pt>
                <c:pt idx="1">
                  <c:v>6-12 months (N=213)</c:v>
                </c:pt>
                <c:pt idx="2">
                  <c:v>12-18 months (N=299)</c:v>
                </c:pt>
                <c:pt idx="3">
                  <c:v>&gt;18 months (N=161)</c:v>
                </c:pt>
              </c:strCache>
            </c:strRef>
          </c:cat>
          <c:val>
            <c:numRef>
              <c:f>'[1]Fig S1 Ancienneté du COVID'!$B$14:$E$14</c:f>
              <c:numCache>
                <c:formatCode>General</c:formatCode>
                <c:ptCount val="4"/>
                <c:pt idx="0">
                  <c:v>3.5050500000000002</c:v>
                </c:pt>
                <c:pt idx="1">
                  <c:v>3.792141</c:v>
                </c:pt>
                <c:pt idx="2">
                  <c:v>3.4452729999999998</c:v>
                </c:pt>
                <c:pt idx="3">
                  <c:v>3.56707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034-5C40-8AC0-426C05C3D8F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0625920"/>
        <c:axId val="100180352"/>
      </c:lineChart>
      <c:catAx>
        <c:axId val="70625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00180352"/>
        <c:crosses val="autoZero"/>
        <c:auto val="1"/>
        <c:lblAlgn val="ctr"/>
        <c:lblOffset val="100"/>
        <c:noMultiLvlLbl val="0"/>
      </c:catAx>
      <c:valAx>
        <c:axId val="100180352"/>
        <c:scaling>
          <c:orientation val="minMax"/>
          <c:max val="4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/>
                  <a:t>Mean scor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706259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85D1B58-0A8B-CAAD-3D1B-2BF0E380769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79B47474-F254-592E-9CA5-312141AB61A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570385A-F263-D6F0-80EB-DDADE93F9A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1020-E828-9D44-856D-324486E5CF5D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171F385-F379-A83A-2C60-9F5ACEB405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0BFCFBE-C968-CD27-57A9-41486F04F7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5C106-E02F-3C46-BAD8-C0512119D90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767102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92E7A26-EF17-B191-A90C-89C82F7066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C0745DD-C707-7B07-62B5-2CD91C3DBA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E10317F-6E7E-5B2B-1655-36CF234204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1020-E828-9D44-856D-324486E5CF5D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E761C46-00D8-0E9E-DAC0-F2E9CD436F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53F275A-2BF8-FC65-8252-12EDB03649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5C106-E02F-3C46-BAD8-C0512119D90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83238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A0CAE02E-C7EE-035F-0A31-F185CB5F26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EF5B7AF-79F1-64BF-9FF6-4B0CA54CD5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AAFABA2-5441-2BA9-E160-8B273D565B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1020-E828-9D44-856D-324486E5CF5D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12EA3DB-1235-6854-407B-B9C35136C5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96EC31D-2CDB-45D3-F7F2-C8C64B8463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5C106-E02F-3C46-BAD8-C0512119D90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9869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58029D1-850D-A376-2AAE-A9CC9EB724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F202E89-8328-9A86-3F2F-56FF79DE1BD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D6EEB8F-C390-214A-DF39-35FB37CD12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1020-E828-9D44-856D-324486E5CF5D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1B5B8B3-F365-7BAF-8F5B-E3B61F5E34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0BCFEE8-5DD3-4A65-EDF5-4AFA3C05D2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5C106-E02F-3C46-BAD8-C0512119D90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97161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6BC1DA3-1618-6407-1385-26FFCC47F1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8D91B7B-9D70-4F81-7541-87CFABCAE3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4D5A8D0-6EED-2973-F50D-9D2D6A2429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1020-E828-9D44-856D-324486E5CF5D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3A24B42-3AFD-6459-264F-06029E72A6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41228CD-96B4-BA8E-E52D-E815C69EB8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5C106-E02F-3C46-BAD8-C0512119D90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5768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C50B106-9ABB-AE07-60CC-F342DE3052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ADBE2A0-B22D-9A98-982A-EF66FDDD165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342A9E66-A8E2-1E44-ADF8-D7A6A8AC8F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5401CE6-97DD-D2BF-BFE2-C89AD88686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1020-E828-9D44-856D-324486E5CF5D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3C1E42A-028D-335B-F3F0-3014949785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279712B3-A75D-A2EF-752F-344E96C7B8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5C106-E02F-3C46-BAD8-C0512119D90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730655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7B9F9E3-6068-29AC-0E2D-033038ED0C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A5CAF5E-D8BB-BA68-1CF5-B34F936C3D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BC14FCBE-62B9-2C25-25FE-F66F1161E6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19B77D1E-AC3C-131C-7C32-56B4A442D36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D1A19A7B-AB02-013D-0926-9B0BF694FA7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2F1A40BB-A691-81AC-C985-88AA84141A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1020-E828-9D44-856D-324486E5CF5D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CF596D1D-2DB1-661F-232D-21A075CD05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D4214E14-2D09-9F0D-55B4-43B90F85DF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5C106-E02F-3C46-BAD8-C0512119D90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977555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85F99EE-8C53-EA41-1112-BC4ACAAE8B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348ABD95-F96D-DB34-DDBE-613D7A3BA2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1020-E828-9D44-856D-324486E5CF5D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A03B8406-7A46-936D-2FDD-D4C49C7007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1C18E00D-6036-7002-5E5E-D67D64FFD1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5C106-E02F-3C46-BAD8-C0512119D90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39326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38193188-8DB3-1632-471E-592427E2CF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1020-E828-9D44-856D-324486E5CF5D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4B1D33FB-E917-728D-2EC8-5B4FCFFA90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E811923F-DC6E-E5D9-0E6D-C3E195937F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5C106-E02F-3C46-BAD8-C0512119D90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79242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DA74A77-72FE-6E32-F7F5-DA79CAE0A5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8B49F62-09B8-99D8-7A7E-F65B20B2D4E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3D00982-1016-AD69-81E5-7BA7AFE288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E87B045B-9207-9120-2D2D-3B47962AD6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1020-E828-9D44-856D-324486E5CF5D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AA83C66-C1F4-BA4B-763A-FD5F7B342D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8B5B9CC-D6CD-AAE8-6487-922EB2E5F3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5C106-E02F-3C46-BAD8-C0512119D90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44923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A8E0BA6-5C44-C7D0-70CC-A490F52D52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DDAF7BB5-4B55-6EF5-196F-BDECAE391F4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85D5426-201B-CABF-DA98-5DD6009070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1314CD2-9218-A192-5842-962B1B48F4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91020-E828-9D44-856D-324486E5CF5D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D20FD18-A08F-A20A-906B-EB6C00813E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EDBA478-90CE-6D05-81EF-2091D28F99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5C106-E02F-3C46-BAD8-C0512119D90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68649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F6971F24-0EB2-1619-2D46-DB15BF1CE0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1653C93-E0FD-CF37-7169-AF049E80EE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9345941-7249-3AA8-1A55-ABF673BF722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991020-E828-9D44-856D-324486E5CF5D}" type="datetimeFigureOut">
              <a:rPr lang="fr-FR" smtClean="0"/>
              <a:t>26/09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B59D12B-DD73-DA50-C838-8AEBA2DD575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AE3331B-6DA2-FEB7-D96D-B5046996C0F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F5C106-E02F-3C46-BAD8-C0512119D90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50780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>
            <a:extLst>
              <a:ext uri="{FF2B5EF4-FFF2-40B4-BE49-F238E27FC236}">
                <a16:creationId xmlns:a16="http://schemas.microsoft.com/office/drawing/2014/main" id="{A191891F-7779-324F-9B47-847A3521CE5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40580580"/>
              </p:ext>
            </p:extLst>
          </p:nvPr>
        </p:nvGraphicFramePr>
        <p:xfrm>
          <a:off x="267638" y="831273"/>
          <a:ext cx="11656723" cy="5516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80634040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2</Words>
  <Application>Microsoft Office PowerPoint</Application>
  <PresentationFormat>Grand écran</PresentationFormat>
  <Paragraphs>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aptiste Pignon</dc:creator>
  <cp:lastModifiedBy>TEBEKA Sarah</cp:lastModifiedBy>
  <cp:revision>2</cp:revision>
  <dcterms:created xsi:type="dcterms:W3CDTF">2023-04-13T07:02:40Z</dcterms:created>
  <dcterms:modified xsi:type="dcterms:W3CDTF">2023-09-26T08:43:25Z</dcterms:modified>
</cp:coreProperties>
</file>